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ve Reiner" initials="DR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829FC6"/>
    <a:srgbClr val="D5A6A8"/>
    <a:srgbClr val="BB6A6B"/>
    <a:srgbClr val="A23739"/>
    <a:srgbClr val="842B2E"/>
    <a:srgbClr val="54647B"/>
    <a:srgbClr val="435061"/>
    <a:srgbClr val="379D51"/>
    <a:srgbClr val="87A2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61" autoAdjust="0"/>
    <p:restoredTop sz="95900" autoAdjust="0"/>
  </p:normalViewPr>
  <p:slideViewPr>
    <p:cSldViewPr snapToGrid="0" snapToObjects="1">
      <p:cViewPr varScale="1">
        <p:scale>
          <a:sx n="119" d="100"/>
          <a:sy n="119" d="100"/>
        </p:scale>
        <p:origin x="74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FE6614-ACFD-1A4E-84EA-CCC941037853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153C66-FF18-934A-B879-113FDC330D8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4530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7153C66-FF18-934A-B879-113FDC330D85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7218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142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2614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0713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3116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760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3476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2998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8817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9223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3679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4654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0015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73016464"/>
              </p:ext>
            </p:extLst>
          </p:nvPr>
        </p:nvGraphicFramePr>
        <p:xfrm>
          <a:off x="208722" y="1600200"/>
          <a:ext cx="8825948" cy="175260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5804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35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6794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enotype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NA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% </a:t>
                      </a:r>
                      <a:r>
                        <a:rPr lang="en-US" b="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ethality</a:t>
                      </a:r>
                      <a:r>
                        <a:rPr lang="en-US" b="0" i="1" baseline="3000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</a:t>
                      </a:r>
                      <a:endParaRPr lang="en-US" b="0" i="1" baseline="300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smg-1(cc546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ts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;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 reIs14[P</a:t>
                      </a:r>
                      <a:r>
                        <a:rPr lang="en-US" i="1" baseline="-25000" dirty="0">
                          <a:latin typeface="Arial" charset="0"/>
                          <a:ea typeface="Arial" charset="0"/>
                          <a:cs typeface="Arial" charset="0"/>
                        </a:rPr>
                        <a:t>lin-26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::egl-1(+)::NMD</a:t>
                      </a:r>
                      <a:r>
                        <a:rPr lang="en-US" i="1" baseline="30000" dirty="0">
                          <a:latin typeface="Arial" charset="0"/>
                          <a:ea typeface="Arial" charset="0"/>
                          <a:cs typeface="Arial" charset="0"/>
                        </a:rPr>
                        <a:t>S</a:t>
                      </a:r>
                      <a:r>
                        <a:rPr lang="en-US" i="1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3’UTR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]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Luc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98.5</a:t>
                      </a:r>
                      <a:r>
                        <a:rPr lang="en-US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321/326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smg-1(cc546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ts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;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 reIs14[P</a:t>
                      </a:r>
                      <a:r>
                        <a:rPr lang="en-US" i="1" baseline="-25000" dirty="0">
                          <a:latin typeface="Arial" charset="0"/>
                          <a:ea typeface="Arial" charset="0"/>
                          <a:cs typeface="Arial" charset="0"/>
                        </a:rPr>
                        <a:t>lin-26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::egl-1(+)::NMD</a:t>
                      </a:r>
                      <a:r>
                        <a:rPr lang="en-US" i="1" baseline="30000" dirty="0">
                          <a:latin typeface="Arial" charset="0"/>
                          <a:ea typeface="Arial" charset="0"/>
                          <a:cs typeface="Arial" charset="0"/>
                        </a:rPr>
                        <a:t>S</a:t>
                      </a:r>
                      <a:r>
                        <a:rPr lang="en-US" i="1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3’UTR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]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ced-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84.8 (245/289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smg-1(cc546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ts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)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;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 ced-3(n717)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; 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reIs14[P</a:t>
                      </a:r>
                      <a:r>
                        <a:rPr lang="en-US" i="1" baseline="-25000" dirty="0">
                          <a:latin typeface="Arial" charset="0"/>
                          <a:ea typeface="Arial" charset="0"/>
                          <a:cs typeface="Arial" charset="0"/>
                        </a:rPr>
                        <a:t>lin-26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::egl-1(+)::NMD</a:t>
                      </a:r>
                      <a:r>
                        <a:rPr lang="en-US" i="1" baseline="30000" dirty="0">
                          <a:latin typeface="Arial" charset="0"/>
                          <a:ea typeface="Arial" charset="0"/>
                          <a:cs typeface="Arial" charset="0"/>
                        </a:rPr>
                        <a:t>S</a:t>
                      </a:r>
                      <a:r>
                        <a:rPr lang="en-US" i="1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3’UTR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]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Luc.</a:t>
                      </a:r>
                    </a:p>
                    <a:p>
                      <a:pPr algn="ctr"/>
                      <a:endParaRPr lang="en-US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 11.4 (22/193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98D4BCB6-541D-4B4A-9289-92741C7C2522}"/>
              </a:ext>
            </a:extLst>
          </p:cNvPr>
          <p:cNvSpPr txBox="1">
            <a:spLocks/>
          </p:cNvSpPr>
          <p:nvPr/>
        </p:nvSpPr>
        <p:spPr>
          <a:xfrm>
            <a:off x="112392" y="1114902"/>
            <a:ext cx="9407843" cy="40354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: </a:t>
            </a:r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EGL-1/BH3-only-induced lethality is caspase-dependent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AC1E90EF-65FD-7E43-AF56-44F5920F6061}"/>
              </a:ext>
            </a:extLst>
          </p:cNvPr>
          <p:cNvSpPr txBox="1">
            <a:spLocks/>
          </p:cNvSpPr>
          <p:nvPr/>
        </p:nvSpPr>
        <p:spPr>
          <a:xfrm>
            <a:off x="119271" y="3339548"/>
            <a:ext cx="3167268" cy="40354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i="1" baseline="30000" dirty="0" err="1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Animal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were grown at 25˚C.</a:t>
            </a:r>
          </a:p>
        </p:txBody>
      </p:sp>
    </p:spTree>
    <p:extLst>
      <p:ext uri="{BB962C8B-B14F-4D97-AF65-F5344CB8AC3E}">
        <p14:creationId xmlns:p14="http://schemas.microsoft.com/office/powerpoint/2010/main" val="1693695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937</TotalTime>
  <Words>84</Words>
  <Application>Microsoft Macintosh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Texas A&amp;M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e Reiner</dc:creator>
  <cp:lastModifiedBy>Microsoft Office User</cp:lastModifiedBy>
  <cp:revision>395</cp:revision>
  <cp:lastPrinted>2021-02-03T22:42:10Z</cp:lastPrinted>
  <dcterms:created xsi:type="dcterms:W3CDTF">2015-07-16T15:46:30Z</dcterms:created>
  <dcterms:modified xsi:type="dcterms:W3CDTF">2021-07-02T21:57:06Z</dcterms:modified>
</cp:coreProperties>
</file>